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75" r:id="rId3"/>
    <p:sldId id="257" r:id="rId4"/>
    <p:sldId id="258" r:id="rId5"/>
    <p:sldId id="259" r:id="rId6"/>
    <p:sldId id="262" r:id="rId7"/>
    <p:sldId id="263" r:id="rId8"/>
    <p:sldId id="265" r:id="rId9"/>
    <p:sldId id="266" r:id="rId10"/>
    <p:sldId id="267" r:id="rId11"/>
    <p:sldId id="277" r:id="rId12"/>
    <p:sldId id="268" r:id="rId13"/>
    <p:sldId id="271" r:id="rId14"/>
    <p:sldId id="280" r:id="rId15"/>
    <p:sldId id="281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43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4459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2791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116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271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2645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880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1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298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751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475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C1729-C6A1-4252-8F8A-F823809ECE60}" type="datetimeFigureOut">
              <a:rPr lang="zh-CN" altLang="en-US" smtClean="0"/>
              <a:t>2022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B5AA6-BB13-4BE9-B2C2-FC6296BCFF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7440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13" Type="http://schemas.openxmlformats.org/officeDocument/2006/relationships/image" Target="../media/image71.png"/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12" Type="http://schemas.openxmlformats.org/officeDocument/2006/relationships/image" Target="../media/image70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png"/><Relationship Id="rId11" Type="http://schemas.openxmlformats.org/officeDocument/2006/relationships/image" Target="../media/image69.png"/><Relationship Id="rId5" Type="http://schemas.openxmlformats.org/officeDocument/2006/relationships/image" Target="../media/image63.png"/><Relationship Id="rId10" Type="http://schemas.openxmlformats.org/officeDocument/2006/relationships/image" Target="../media/image68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13" Type="http://schemas.openxmlformats.org/officeDocument/2006/relationships/image" Target="../media/image83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12" Type="http://schemas.openxmlformats.org/officeDocument/2006/relationships/image" Target="../media/image82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6.png"/><Relationship Id="rId11" Type="http://schemas.openxmlformats.org/officeDocument/2006/relationships/image" Target="../media/image81.png"/><Relationship Id="rId5" Type="http://schemas.openxmlformats.org/officeDocument/2006/relationships/image" Target="../media/image75.png"/><Relationship Id="rId10" Type="http://schemas.openxmlformats.org/officeDocument/2006/relationships/image" Target="../media/image80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7.png"/><Relationship Id="rId4" Type="http://schemas.openxmlformats.org/officeDocument/2006/relationships/image" Target="../media/image8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1.png"/><Relationship Id="rId4" Type="http://schemas.openxmlformats.org/officeDocument/2006/relationships/image" Target="../media/image9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12" Type="http://schemas.openxmlformats.org/officeDocument/2006/relationships/image" Target="../media/image28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5956" y="1032049"/>
            <a:ext cx="3098427" cy="216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3933" y="1212049"/>
            <a:ext cx="2582023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762" y="3232099"/>
            <a:ext cx="3098427" cy="216000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48590" y="1778160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42177" y="4048881"/>
            <a:ext cx="8835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β-ACTIN</a:t>
            </a:r>
          </a:p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42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11480" y="308610"/>
            <a:ext cx="1311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1D</a:t>
            </a:r>
            <a:endParaRPr lang="zh-CN" altLang="en-US" sz="2000" b="1" dirty="0"/>
          </a:p>
        </p:txBody>
      </p:sp>
      <p:sp>
        <p:nvSpPr>
          <p:cNvPr id="11" name="矩形 10"/>
          <p:cNvSpPr/>
          <p:nvPr/>
        </p:nvSpPr>
        <p:spPr>
          <a:xfrm>
            <a:off x="3827260" y="1778160"/>
            <a:ext cx="2295244" cy="11027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1170528" y="4216564"/>
            <a:ext cx="2457253" cy="17653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3451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5I</a:t>
            </a:r>
            <a:endParaRPr lang="zh-CN" altLang="en-US" sz="2000" b="1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0632" y="950810"/>
            <a:ext cx="1269420" cy="216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图片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8829" y="950810"/>
            <a:ext cx="1276941" cy="216000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1338775" y="3098518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603252" y="310555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338775" y="2135699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2717355" y="1860138"/>
            <a:ext cx="790226" cy="28991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24969" y="950810"/>
            <a:ext cx="1256864" cy="216000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2135" y="945554"/>
            <a:ext cx="1226118" cy="21600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4632974" y="2050774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5599755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6049845" y="3092230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314322" y="3099266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6036086" y="2242635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7367904" y="1916727"/>
            <a:ext cx="790226" cy="315969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24826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7409" y="940871"/>
            <a:ext cx="3382642" cy="2160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5806128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3005" y="940871"/>
            <a:ext cx="3249672" cy="2160000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75991" y="2155577"/>
            <a:ext cx="1407166" cy="26356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6358633" y="1869209"/>
            <a:ext cx="1370150" cy="28636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411480" y="308610"/>
            <a:ext cx="1364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5M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2412740" y="3100871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7409" y="3931072"/>
            <a:ext cx="3467958" cy="216000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-52372" y="5040975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914409" y="3931072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5011" y="3931072"/>
            <a:ext cx="3401525" cy="216000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5806128" y="6091072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412740" y="6091072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1508312" y="5194927"/>
            <a:ext cx="1407166" cy="26356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5072728" y="4879288"/>
            <a:ext cx="1407166" cy="26356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8691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3067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6G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708" y="940871"/>
            <a:ext cx="1386886" cy="2160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5662622" y="3108459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441854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558230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343735" y="3108459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774094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324860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323135" y="1193298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3872" y="948459"/>
            <a:ext cx="1323871" cy="216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53852" y="940871"/>
            <a:ext cx="1129737" cy="216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80184" y="940871"/>
            <a:ext cx="1168302" cy="216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21808" y="940871"/>
            <a:ext cx="1133465" cy="216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62723" y="940871"/>
            <a:ext cx="1194437" cy="2160000"/>
          </a:xfrm>
          <a:prstGeom prst="rect">
            <a:avLst/>
          </a:prstGeom>
        </p:spPr>
      </p:pic>
      <p:sp>
        <p:nvSpPr>
          <p:cNvPr id="18" name="矩形 17"/>
          <p:cNvSpPr/>
          <p:nvPr/>
        </p:nvSpPr>
        <p:spPr>
          <a:xfrm>
            <a:off x="8587196" y="1767125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529170" y="1359869"/>
            <a:ext cx="696233" cy="28008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7333796" y="1389686"/>
            <a:ext cx="773608" cy="292597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-53165" y="4907277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913616" y="3797374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7" name="图片 2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5708" y="3797374"/>
            <a:ext cx="1160816" cy="216000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95503" y="3797374"/>
            <a:ext cx="1125818" cy="2160000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2456700" y="5925832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245504" y="5933420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288366" y="4024858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21808" y="3827277"/>
            <a:ext cx="1342703" cy="216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558230" y="3827277"/>
            <a:ext cx="1413026" cy="2160000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>
            <a:off x="8908364" y="5949786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7509957" y="5957374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7465047" y="4241209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8948120" y="4641368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68920" y="3797374"/>
            <a:ext cx="1352656" cy="216000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19235" y="3797460"/>
            <a:ext cx="1285886" cy="2160000"/>
          </a:xfrm>
          <a:prstGeom prst="rect">
            <a:avLst/>
          </a:prstGeom>
        </p:spPr>
      </p:pic>
      <p:sp>
        <p:nvSpPr>
          <p:cNvPr id="41" name="文本框 40"/>
          <p:cNvSpPr txBox="1"/>
          <p:nvPr/>
        </p:nvSpPr>
        <p:spPr>
          <a:xfrm>
            <a:off x="5609588" y="5924107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246694" y="5924107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4281090" y="4208037"/>
            <a:ext cx="696233" cy="28008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8860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321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6O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6670" y="940871"/>
            <a:ext cx="1298534" cy="216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4166" y="940871"/>
            <a:ext cx="1240616" cy="216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338775" y="3098518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603252" y="310555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71328" y="945554"/>
            <a:ext cx="1178761" cy="216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21322" y="938518"/>
            <a:ext cx="1221428" cy="2160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4415470" y="3105554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P16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6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630323" y="3112590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26207" y="938518"/>
            <a:ext cx="1463920" cy="216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81003" y="938518"/>
            <a:ext cx="1454845" cy="216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9006712" y="3090930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539003" y="3098518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331172" y="2095943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409855" y="2476943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7376491" y="1252330"/>
            <a:ext cx="839383" cy="326777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2667326" y="1752047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-53165" y="4907277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913616" y="3797374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6" name="图片 2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4166" y="3797374"/>
            <a:ext cx="1165341" cy="21600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1280644" y="5957374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455358" y="595737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74782" y="3797374"/>
            <a:ext cx="1164578" cy="2160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1285583" y="5076554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71328" y="3797374"/>
            <a:ext cx="1118951" cy="216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50089" y="3797374"/>
            <a:ext cx="1145854" cy="2160000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4419794" y="5340123"/>
            <a:ext cx="765844" cy="30530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4415470" y="5957374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P16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6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5521303" y="5964410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126207" y="3797374"/>
            <a:ext cx="1142237" cy="2160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42540" y="3797374"/>
            <a:ext cx="1112335" cy="2160000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8496994" y="5945523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7399265" y="5953111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7344258" y="4282843"/>
            <a:ext cx="744619" cy="2898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2508313" y="4750559"/>
            <a:ext cx="790226" cy="29338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179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7430" y="3831766"/>
            <a:ext cx="3098427" cy="216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5857" y="3831766"/>
            <a:ext cx="3751837" cy="2160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694931" y="5989231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900225" y="598923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694931" y="2699048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900226" y="2699048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7430" y="539048"/>
            <a:ext cx="3098427" cy="216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06958" y="539048"/>
            <a:ext cx="3098427" cy="2160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871444" y="1648951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2386283" y="539048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1419502" y="4911766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2386283" y="3801863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411480" y="308610"/>
            <a:ext cx="1438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smtClean="0"/>
              <a:t>Figure S3A</a:t>
            </a:r>
            <a:endParaRPr lang="zh-CN" altLang="en-US" sz="2000" b="1" dirty="0"/>
          </a:p>
        </p:txBody>
      </p:sp>
      <p:sp>
        <p:nvSpPr>
          <p:cNvPr id="15" name="矩形 14"/>
          <p:cNvSpPr/>
          <p:nvPr/>
        </p:nvSpPr>
        <p:spPr>
          <a:xfrm>
            <a:off x="3816626" y="1444888"/>
            <a:ext cx="983974" cy="19412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7029787" y="1521986"/>
            <a:ext cx="1100422" cy="19748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3353065" y="4757771"/>
            <a:ext cx="1100422" cy="19748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7029787" y="4864110"/>
            <a:ext cx="1100422" cy="19748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09689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8921" y="647369"/>
            <a:ext cx="3098427" cy="216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2017" y="647369"/>
            <a:ext cx="3098427" cy="216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8922" y="4157579"/>
            <a:ext cx="3098427" cy="216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92016" y="4157579"/>
            <a:ext cx="3098427" cy="21600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416151" y="2807369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3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699441" y="6334780"/>
            <a:ext cx="8835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β-ACTIN</a:t>
            </a:r>
          </a:p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42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11480" y="179403"/>
            <a:ext cx="1438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</a:t>
            </a:r>
            <a:r>
              <a:rPr lang="en-US" altLang="zh-CN" sz="2000" b="1" dirty="0" smtClean="0"/>
              <a:t>S7A</a:t>
            </a:r>
            <a:endParaRPr lang="zh-CN" altLang="en-US" sz="2000" b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6699441" y="2807369"/>
            <a:ext cx="8835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β-ACTIN</a:t>
            </a:r>
          </a:p>
          <a:p>
            <a:pPr algn="ctr"/>
            <a:r>
              <a:rPr lang="en-US" altLang="zh-CN" sz="1400">
                <a:latin typeface="Times" panose="02020603050405020304" pitchFamily="18" charset="0"/>
                <a:cs typeface="Times" panose="02020603050405020304" pitchFamily="18" charset="0"/>
              </a:rPr>
              <a:t>42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416151" y="6317579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3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997764" y="1229723"/>
            <a:ext cx="1500809" cy="17890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2219737" y="4922151"/>
            <a:ext cx="1500809" cy="17890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6357727" y="1279419"/>
            <a:ext cx="1500809" cy="17890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6530005" y="4869143"/>
            <a:ext cx="1610142" cy="261729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11480" y="3757469"/>
            <a:ext cx="1438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</a:t>
            </a:r>
            <a:r>
              <a:rPr lang="en-US" altLang="zh-CN" sz="2000" b="1" dirty="0" smtClean="0"/>
              <a:t>S7B</a:t>
            </a:r>
            <a:endParaRPr lang="zh-CN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2777176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538" y="1147884"/>
            <a:ext cx="2730000" cy="216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8484" y="1147884"/>
            <a:ext cx="2737190" cy="216000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824948" y="2227884"/>
            <a:ext cx="2315818" cy="30651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3649048" y="1981756"/>
            <a:ext cx="2315818" cy="30651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411480" y="308610"/>
            <a:ext cx="13067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1G</a:t>
            </a:r>
            <a:endParaRPr lang="zh-CN" altLang="en-US" sz="2000" b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1547334" y="3307884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305216" y="3307884"/>
            <a:ext cx="8835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β-ACTIN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42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070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2987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2A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2491" y="977265"/>
            <a:ext cx="1269818" cy="216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5476" y="977265"/>
            <a:ext cx="1299823" cy="216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84" y="979371"/>
            <a:ext cx="1586483" cy="216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89693" y="979371"/>
            <a:ext cx="1500631" cy="216000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305934" y="2077278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6492048" y="1900389"/>
            <a:ext cx="873853" cy="324683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2710440" y="1990700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122205" y="1738047"/>
            <a:ext cx="873853" cy="324683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文本框 44"/>
          <p:cNvSpPr txBox="1"/>
          <p:nvPr/>
        </p:nvSpPr>
        <p:spPr>
          <a:xfrm>
            <a:off x="1242024" y="3137265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641887" y="3137265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591674" y="3136013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8140399" y="3136013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99570" y="2080591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914409" y="970688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4998952" y="2092911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5965733" y="983008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5818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2602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2E</a:t>
            </a:r>
            <a:endParaRPr lang="zh-CN" altLang="en-US" sz="2000" b="1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8605" y="941734"/>
            <a:ext cx="1206667" cy="216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2550" y="941734"/>
            <a:ext cx="1251477" cy="216000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354249" y="1789384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80725" y="941735"/>
            <a:ext cx="1223301" cy="2160000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4239036" y="2458618"/>
            <a:ext cx="788869" cy="29452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98912" y="941734"/>
            <a:ext cx="1236069" cy="2160000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5587823" y="1809932"/>
            <a:ext cx="788869" cy="29452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2550" y="3824081"/>
            <a:ext cx="1253009" cy="216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92450" y="3827955"/>
            <a:ext cx="1316418" cy="2160000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1304572" y="4702912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1359545" y="3097915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</a:p>
          <a:p>
            <a:pPr algn="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492781" y="3090327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542170" y="3097915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2648946" y="5980262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333064" y="5974189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</a:p>
          <a:p>
            <a:pPr algn="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269055" y="3090322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6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-53165" y="4907277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913616" y="3797374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" name="图片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80725" y="3818016"/>
            <a:ext cx="1341611" cy="2166065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4307982" y="5188226"/>
            <a:ext cx="856288" cy="25841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94034" y="3809284"/>
            <a:ext cx="1381942" cy="2184783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>
            <a:off x="5631621" y="5974189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318750" y="5966596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6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2650042" y="4598685"/>
            <a:ext cx="772512" cy="30859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97511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1853" y="940871"/>
            <a:ext cx="1296000" cy="2160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11480" y="308610"/>
            <a:ext cx="13163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2H</a:t>
            </a:r>
            <a:endParaRPr lang="zh-CN" altLang="en-US" sz="20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1524" y="940871"/>
            <a:ext cx="1280804" cy="2160000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1303050" y="1133179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0822" y="945801"/>
            <a:ext cx="1171011" cy="216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3819" y="945801"/>
            <a:ext cx="1189091" cy="2160000"/>
          </a:xfrm>
          <a:prstGeom prst="rect">
            <a:avLst/>
          </a:prstGeom>
        </p:spPr>
      </p:pic>
      <p:sp>
        <p:nvSpPr>
          <p:cNvPr id="27" name="矩形 26"/>
          <p:cNvSpPr/>
          <p:nvPr/>
        </p:nvSpPr>
        <p:spPr>
          <a:xfrm>
            <a:off x="4381027" y="1354945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2625992" y="1811430"/>
            <a:ext cx="792747" cy="293817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94475" y="940871"/>
            <a:ext cx="1252544" cy="2160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15130" y="945801"/>
            <a:ext cx="1246405" cy="2160000"/>
          </a:xfrm>
          <a:prstGeom prst="rect">
            <a:avLst/>
          </a:prstGeom>
        </p:spPr>
      </p:pic>
      <p:sp>
        <p:nvSpPr>
          <p:cNvPr id="38" name="矩形 37"/>
          <p:cNvSpPr/>
          <p:nvPr/>
        </p:nvSpPr>
        <p:spPr>
          <a:xfrm>
            <a:off x="7254665" y="1334771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2645242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548089" y="3108459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8464437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324860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315113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7249942" y="3108459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9" name="图片 4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56735" y="3797374"/>
            <a:ext cx="1212737" cy="216000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18909" y="3797374"/>
            <a:ext cx="1204034" cy="2160000"/>
          </a:xfrm>
          <a:prstGeom prst="rect">
            <a:avLst/>
          </a:prstGeom>
        </p:spPr>
      </p:pic>
      <p:sp>
        <p:nvSpPr>
          <p:cNvPr id="53" name="文本框 52"/>
          <p:cNvSpPr txBox="1"/>
          <p:nvPr/>
        </p:nvSpPr>
        <p:spPr>
          <a:xfrm>
            <a:off x="5585128" y="595737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4352152" y="5957374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4376956" y="4231759"/>
            <a:ext cx="673647" cy="24300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/>
          <p:cNvSpPr txBox="1"/>
          <p:nvPr/>
        </p:nvSpPr>
        <p:spPr>
          <a:xfrm>
            <a:off x="-53165" y="4907277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/>
          <p:cNvCxnSpPr/>
          <p:nvPr/>
        </p:nvCxnSpPr>
        <p:spPr>
          <a:xfrm>
            <a:off x="913616" y="3797374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8" name="图片 5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51853" y="3797374"/>
            <a:ext cx="1157938" cy="2160000"/>
          </a:xfrm>
          <a:prstGeom prst="rect">
            <a:avLst/>
          </a:prstGeom>
        </p:spPr>
      </p:pic>
      <p:sp>
        <p:nvSpPr>
          <p:cNvPr id="59" name="文本框 58"/>
          <p:cNvSpPr txBox="1"/>
          <p:nvPr/>
        </p:nvSpPr>
        <p:spPr>
          <a:xfrm>
            <a:off x="2483745" y="5949786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1332571" y="5957374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" name="图片 6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99338" y="3797374"/>
            <a:ext cx="1174369" cy="2160000"/>
          </a:xfrm>
          <a:prstGeom prst="rect">
            <a:avLst/>
          </a:prstGeom>
        </p:spPr>
      </p:pic>
      <p:sp>
        <p:nvSpPr>
          <p:cNvPr id="62" name="矩形 61"/>
          <p:cNvSpPr/>
          <p:nvPr/>
        </p:nvSpPr>
        <p:spPr>
          <a:xfrm>
            <a:off x="1400358" y="4012014"/>
            <a:ext cx="673647" cy="24300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3" name="图片 6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894475" y="3807428"/>
            <a:ext cx="1141554" cy="2160000"/>
          </a:xfrm>
          <a:prstGeom prst="rect">
            <a:avLst/>
          </a:prstGeom>
        </p:spPr>
      </p:pic>
      <p:sp>
        <p:nvSpPr>
          <p:cNvPr id="64" name="矩形 63"/>
          <p:cNvSpPr/>
          <p:nvPr/>
        </p:nvSpPr>
        <p:spPr>
          <a:xfrm>
            <a:off x="7155048" y="4235766"/>
            <a:ext cx="755631" cy="316984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5" name="图片 6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129911" y="3807428"/>
            <a:ext cx="1137951" cy="2160000"/>
          </a:xfrm>
          <a:prstGeom prst="rect">
            <a:avLst/>
          </a:prstGeom>
        </p:spPr>
      </p:pic>
      <p:sp>
        <p:nvSpPr>
          <p:cNvPr id="66" name="文本框 65"/>
          <p:cNvSpPr txBox="1"/>
          <p:nvPr/>
        </p:nvSpPr>
        <p:spPr>
          <a:xfrm>
            <a:off x="8326908" y="5943116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7131663" y="5950704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2616367" y="4736297"/>
            <a:ext cx="742856" cy="307341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864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2I</a:t>
            </a:r>
            <a:endParaRPr lang="zh-CN" altLang="en-US" sz="2000" b="1" dirty="0"/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8179" y="821720"/>
            <a:ext cx="1160229" cy="2160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1154890" y="1858617"/>
            <a:ext cx="756043" cy="20872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7644" y="829123"/>
            <a:ext cx="1153842" cy="2152598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2412232" y="1747986"/>
            <a:ext cx="690728" cy="23984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94104" y="829123"/>
            <a:ext cx="1103102" cy="216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80843" y="829123"/>
            <a:ext cx="1122234" cy="2160000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292328" y="1931623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807167" y="821720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4613096" y="1939026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5579877" y="829123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1052917" y="2988400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314157" y="2971148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816258" y="2982895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7077498" y="2965643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5924039" y="1838739"/>
            <a:ext cx="756043" cy="208722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7180256" y="1747986"/>
            <a:ext cx="690728" cy="23984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9182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364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2M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1152" y="940871"/>
            <a:ext cx="1145559" cy="21600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83434" y="940871"/>
            <a:ext cx="1121860" cy="21600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5697176" y="3108459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464200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19730" y="940871"/>
            <a:ext cx="1329231" cy="216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28475" y="948459"/>
            <a:ext cx="1298919" cy="216000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8717254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502759" y="3108459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9640" y="948459"/>
            <a:ext cx="1313280" cy="216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58227" y="940871"/>
            <a:ext cx="1320764" cy="216000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2645242" y="3100871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324860" y="3108459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1402440" y="1103362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4549019" y="1365092"/>
            <a:ext cx="700044" cy="279453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7452606" y="1345214"/>
            <a:ext cx="759643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2792895" y="1848678"/>
            <a:ext cx="781489" cy="288235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61152" y="3797374"/>
            <a:ext cx="1129412" cy="216000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83434" y="3797374"/>
            <a:ext cx="1112508" cy="21600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5677298" y="595737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464200" y="5957374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19730" y="3797374"/>
            <a:ext cx="1194199" cy="2160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79346" y="3797374"/>
            <a:ext cx="1141333" cy="21600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8568169" y="595737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403369" y="5964962"/>
            <a:ext cx="6896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559227" y="5950848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328296" y="5958436"/>
            <a:ext cx="75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AD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-53165" y="4907277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913616" y="3797374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矩形 39"/>
          <p:cNvSpPr/>
          <p:nvPr/>
        </p:nvSpPr>
        <p:spPr>
          <a:xfrm>
            <a:off x="4561252" y="4248597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7406372" y="4258536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2" name="图片 4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39640" y="3790848"/>
            <a:ext cx="1182385" cy="2160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25706" y="3790848"/>
            <a:ext cx="1194750" cy="2160000"/>
          </a:xfrm>
          <a:prstGeom prst="rect">
            <a:avLst/>
          </a:prstGeom>
        </p:spPr>
      </p:pic>
      <p:sp>
        <p:nvSpPr>
          <p:cNvPr id="44" name="矩形 43"/>
          <p:cNvSpPr/>
          <p:nvPr/>
        </p:nvSpPr>
        <p:spPr>
          <a:xfrm>
            <a:off x="1304291" y="3950918"/>
            <a:ext cx="700044" cy="30927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2598983" y="4742703"/>
            <a:ext cx="751734" cy="286497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3576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2987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3A</a:t>
            </a:r>
            <a:endParaRPr lang="zh-CN" altLang="en-US" sz="2000" b="1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8133" y="880228"/>
            <a:ext cx="1049616" cy="216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9972" y="880228"/>
            <a:ext cx="1058543" cy="216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225895" y="1990131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1192676" y="880228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矩形 18"/>
          <p:cNvSpPr/>
          <p:nvPr/>
        </p:nvSpPr>
        <p:spPr>
          <a:xfrm>
            <a:off x="1563265" y="1861616"/>
            <a:ext cx="686849" cy="273127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2688499" y="1709531"/>
            <a:ext cx="720623" cy="290540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1397565" y="3018458"/>
            <a:ext cx="8707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TL1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562637" y="3013667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11840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11480" y="308610"/>
            <a:ext cx="13067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Figure 5G</a:t>
            </a:r>
            <a:endParaRPr lang="zh-CN" altLang="en-US" sz="20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6267" y="944355"/>
            <a:ext cx="1248980" cy="2160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1036" y="944355"/>
            <a:ext cx="1247859" cy="21600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99570" y="205077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914409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338775" y="3098518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2603252" y="3105554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613096" y="2050774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-UC3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5579877" y="940871"/>
            <a:ext cx="0" cy="2589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0" name="图片 3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23874" y="945554"/>
            <a:ext cx="1169773" cy="21600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0127" y="945554"/>
            <a:ext cx="1201348" cy="2160000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>
            <a:off x="6004242" y="3091482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ATF3</a:t>
            </a:r>
          </a:p>
          <a:p>
            <a:pPr algn="ctr"/>
            <a:r>
              <a:rPr lang="en-US" altLang="zh-CN" sz="14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1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7189088" y="3098518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GAPDH</a:t>
            </a:r>
          </a:p>
          <a:p>
            <a:pPr algn="ctr"/>
            <a:r>
              <a:rPr lang="en-US" altLang="zh-CN" sz="1400" dirty="0" smtClean="0">
                <a:latin typeface="Times" panose="02020603050405020304" pitchFamily="18" charset="0"/>
                <a:cs typeface="Times" panose="02020603050405020304" pitchFamily="18" charset="0"/>
              </a:rPr>
              <a:t>37kDa</a:t>
            </a:r>
            <a:endParaRPr lang="zh-CN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1308958" y="2219625"/>
            <a:ext cx="790226" cy="25702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2663947" y="1869719"/>
            <a:ext cx="722852" cy="310149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/>
          <p:cNvSpPr/>
          <p:nvPr/>
        </p:nvSpPr>
        <p:spPr>
          <a:xfrm>
            <a:off x="5974425" y="2131738"/>
            <a:ext cx="764652" cy="297346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7235850" y="1848816"/>
            <a:ext cx="836641" cy="332618"/>
          </a:xfrm>
          <a:prstGeom prst="rect">
            <a:avLst/>
          </a:prstGeom>
          <a:noFill/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785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4</TotalTime>
  <Words>235</Words>
  <Application>Microsoft Office PowerPoint</Application>
  <PresentationFormat>宽屏</PresentationFormat>
  <Paragraphs>219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1" baseType="lpstr">
      <vt:lpstr>等线</vt:lpstr>
      <vt:lpstr>等线 Light</vt:lpstr>
      <vt:lpstr>Arial</vt:lpstr>
      <vt:lpstr>Times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ZJ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西柚 小茶</dc:creator>
  <cp:lastModifiedBy>西柚 小茶</cp:lastModifiedBy>
  <cp:revision>225</cp:revision>
  <dcterms:created xsi:type="dcterms:W3CDTF">2022-07-12T10:42:22Z</dcterms:created>
  <dcterms:modified xsi:type="dcterms:W3CDTF">2022-09-10T13:15:40Z</dcterms:modified>
</cp:coreProperties>
</file>